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9"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A384ADC-3BC1-43E8-957E-136DADB94FBD}" v="1" dt="2021-12-29T12:22:14.57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7311" autoAdjust="0"/>
    <p:restoredTop sz="94367" autoAdjust="0"/>
  </p:normalViewPr>
  <p:slideViewPr>
    <p:cSldViewPr snapToGrid="0" snapToObjects="1">
      <p:cViewPr varScale="1">
        <p:scale>
          <a:sx n="81" d="100"/>
          <a:sy n="81" d="100"/>
        </p:scale>
        <p:origin x="1219" y="48"/>
      </p:cViewPr>
      <p:guideLst/>
    </p:cSldViewPr>
  </p:slideViewPr>
  <p:notesTextViewPr>
    <p:cViewPr>
      <p:scale>
        <a:sx n="20" d="100"/>
        <a:sy n="20" d="100"/>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u Jintao" userId="6348392d7e799866" providerId="LiveId" clId="{68A9EE4A-F126-46C2-9F74-772F4EE693BA}"/>
    <pc:docChg chg="undo custSel modSld">
      <pc:chgData name="Hu Jintao" userId="6348392d7e799866" providerId="LiveId" clId="{68A9EE4A-F126-46C2-9F74-772F4EE693BA}" dt="2021-12-11T14:55:50.151" v="377" actId="2711"/>
      <pc:docMkLst>
        <pc:docMk/>
      </pc:docMkLst>
      <pc:sldChg chg="addSp delSp modSp mod setBg">
        <pc:chgData name="Hu Jintao" userId="6348392d7e799866" providerId="LiveId" clId="{68A9EE4A-F126-46C2-9F74-772F4EE693BA}" dt="2021-12-11T14:55:50.151" v="377" actId="2711"/>
        <pc:sldMkLst>
          <pc:docMk/>
          <pc:sldMk cId="1061512908" sldId="259"/>
        </pc:sldMkLst>
        <pc:spChg chg="del mod">
          <ac:chgData name="Hu Jintao" userId="6348392d7e799866" providerId="LiveId" clId="{68A9EE4A-F126-46C2-9F74-772F4EE693BA}" dt="2021-12-11T06:40:25.219" v="37" actId="478"/>
          <ac:spMkLst>
            <pc:docMk/>
            <pc:sldMk cId="1061512908" sldId="259"/>
            <ac:spMk id="2" creationId="{E028C2EC-2E68-034F-89C9-3D15DFA6DD8B}"/>
          </ac:spMkLst>
        </pc:spChg>
        <pc:spChg chg="add mod">
          <ac:chgData name="Hu Jintao" userId="6348392d7e799866" providerId="LiveId" clId="{68A9EE4A-F126-46C2-9F74-772F4EE693BA}" dt="2021-12-11T14:51:36.317" v="357" actId="255"/>
          <ac:spMkLst>
            <pc:docMk/>
            <pc:sldMk cId="1061512908" sldId="259"/>
            <ac:spMk id="3" creationId="{66DCADF2-0369-4DC2-A75D-C5DE6F2EBF44}"/>
          </ac:spMkLst>
        </pc:spChg>
        <pc:spChg chg="add mod">
          <ac:chgData name="Hu Jintao" userId="6348392d7e799866" providerId="LiveId" clId="{68A9EE4A-F126-46C2-9F74-772F4EE693BA}" dt="2021-12-11T14:55:50.151" v="377" actId="2711"/>
          <ac:spMkLst>
            <pc:docMk/>
            <pc:sldMk cId="1061512908" sldId="259"/>
            <ac:spMk id="4" creationId="{B4DC734E-AEA2-4910-8CC6-30EC42027CD5}"/>
          </ac:spMkLst>
        </pc:spChg>
        <pc:spChg chg="add mod">
          <ac:chgData name="Hu Jintao" userId="6348392d7e799866" providerId="LiveId" clId="{68A9EE4A-F126-46C2-9F74-772F4EE693BA}" dt="2021-12-11T14:51:36.317" v="357" actId="255"/>
          <ac:spMkLst>
            <pc:docMk/>
            <pc:sldMk cId="1061512908" sldId="259"/>
            <ac:spMk id="5" creationId="{32984EB3-9256-425C-B61F-99D39A23543B}"/>
          </ac:spMkLst>
        </pc:spChg>
        <pc:spChg chg="del">
          <ac:chgData name="Hu Jintao" userId="6348392d7e799866" providerId="LiveId" clId="{68A9EE4A-F126-46C2-9F74-772F4EE693BA}" dt="2021-12-11T06:40:18.836" v="36" actId="26606"/>
          <ac:spMkLst>
            <pc:docMk/>
            <pc:sldMk cId="1061512908" sldId="259"/>
            <ac:spMk id="6" creationId="{01888220-B916-2347-970A-B96FE68FBA3C}"/>
          </ac:spMkLst>
        </pc:spChg>
        <pc:spChg chg="add del mod">
          <ac:chgData name="Hu Jintao" userId="6348392d7e799866" providerId="LiveId" clId="{68A9EE4A-F126-46C2-9F74-772F4EE693BA}" dt="2021-12-11T14:39:22.174" v="197"/>
          <ac:spMkLst>
            <pc:docMk/>
            <pc:sldMk cId="1061512908" sldId="259"/>
            <ac:spMk id="14" creationId="{4A178624-EDAF-4FD5-A002-DEE759DBD11B}"/>
          </ac:spMkLst>
        </pc:spChg>
        <pc:spChg chg="mod">
          <ac:chgData name="Hu Jintao" userId="6348392d7e799866" providerId="LiveId" clId="{68A9EE4A-F126-46C2-9F74-772F4EE693BA}" dt="2021-12-11T14:51:36.317" v="357" actId="255"/>
          <ac:spMkLst>
            <pc:docMk/>
            <pc:sldMk cId="1061512908" sldId="259"/>
            <ac:spMk id="17" creationId="{BC0ACBB3-D658-40E6-8F7E-7D70CFF4DE2F}"/>
          </ac:spMkLst>
        </pc:spChg>
        <pc:spChg chg="mod">
          <ac:chgData name="Hu Jintao" userId="6348392d7e799866" providerId="LiveId" clId="{68A9EE4A-F126-46C2-9F74-772F4EE693BA}" dt="2021-12-11T14:51:36.317" v="357" actId="255"/>
          <ac:spMkLst>
            <pc:docMk/>
            <pc:sldMk cId="1061512908" sldId="259"/>
            <ac:spMk id="18" creationId="{6DAA72A1-08FA-4AFF-A9D4-B6A859A8DBC9}"/>
          </ac:spMkLst>
        </pc:spChg>
        <pc:spChg chg="mod">
          <ac:chgData name="Hu Jintao" userId="6348392d7e799866" providerId="LiveId" clId="{68A9EE4A-F126-46C2-9F74-772F4EE693BA}" dt="2021-12-11T14:51:36.317" v="357" actId="255"/>
          <ac:spMkLst>
            <pc:docMk/>
            <pc:sldMk cId="1061512908" sldId="259"/>
            <ac:spMk id="20" creationId="{0E888F3C-08E8-460D-8FBD-FC034EB0C1D2}"/>
          </ac:spMkLst>
        </pc:spChg>
        <pc:spChg chg="mod">
          <ac:chgData name="Hu Jintao" userId="6348392d7e799866" providerId="LiveId" clId="{68A9EE4A-F126-46C2-9F74-772F4EE693BA}" dt="2021-12-11T14:53:17.002" v="369" actId="20577"/>
          <ac:spMkLst>
            <pc:docMk/>
            <pc:sldMk cId="1061512908" sldId="259"/>
            <ac:spMk id="21" creationId="{9AD14D92-00BD-45AA-9EC6-6FB0FB86074F}"/>
          </ac:spMkLst>
        </pc:spChg>
        <pc:spChg chg="mod">
          <ac:chgData name="Hu Jintao" userId="6348392d7e799866" providerId="LiveId" clId="{68A9EE4A-F126-46C2-9F74-772F4EE693BA}" dt="2021-12-11T14:51:36.317" v="357" actId="255"/>
          <ac:spMkLst>
            <pc:docMk/>
            <pc:sldMk cId="1061512908" sldId="259"/>
            <ac:spMk id="23" creationId="{6B392938-075D-4FD7-8348-277F26317784}"/>
          </ac:spMkLst>
        </pc:spChg>
        <pc:spChg chg="mod">
          <ac:chgData name="Hu Jintao" userId="6348392d7e799866" providerId="LiveId" clId="{68A9EE4A-F126-46C2-9F74-772F4EE693BA}" dt="2021-12-11T14:51:36.317" v="357" actId="255"/>
          <ac:spMkLst>
            <pc:docMk/>
            <pc:sldMk cId="1061512908" sldId="259"/>
            <ac:spMk id="24" creationId="{D867CA17-BE28-466D-A251-E7D9C1B028A4}"/>
          </ac:spMkLst>
        </pc:spChg>
        <pc:spChg chg="mod">
          <ac:chgData name="Hu Jintao" userId="6348392d7e799866" providerId="LiveId" clId="{68A9EE4A-F126-46C2-9F74-772F4EE693BA}" dt="2021-12-11T14:51:36.317" v="357" actId="255"/>
          <ac:spMkLst>
            <pc:docMk/>
            <pc:sldMk cId="1061512908" sldId="259"/>
            <ac:spMk id="26" creationId="{6F096459-40A1-46BD-8C1D-FAEE1A46759D}"/>
          </ac:spMkLst>
        </pc:spChg>
        <pc:spChg chg="mod">
          <ac:chgData name="Hu Jintao" userId="6348392d7e799866" providerId="LiveId" clId="{68A9EE4A-F126-46C2-9F74-772F4EE693BA}" dt="2021-12-11T14:51:36.317" v="357" actId="255"/>
          <ac:spMkLst>
            <pc:docMk/>
            <pc:sldMk cId="1061512908" sldId="259"/>
            <ac:spMk id="27" creationId="{BF3DFD59-3CC0-4926-9A8D-64E4A31B5537}"/>
          </ac:spMkLst>
        </pc:spChg>
        <pc:spChg chg="del mod">
          <ac:chgData name="Hu Jintao" userId="6348392d7e799866" providerId="LiveId" clId="{68A9EE4A-F126-46C2-9F74-772F4EE693BA}" dt="2021-12-11T14:52:54.727" v="363" actId="478"/>
          <ac:spMkLst>
            <pc:docMk/>
            <pc:sldMk cId="1061512908" sldId="259"/>
            <ac:spMk id="29" creationId="{1A43DAEB-3C5D-4C2A-81F4-3C4196CAF0EB}"/>
          </ac:spMkLst>
        </pc:spChg>
        <pc:spChg chg="del mod">
          <ac:chgData name="Hu Jintao" userId="6348392d7e799866" providerId="LiveId" clId="{68A9EE4A-F126-46C2-9F74-772F4EE693BA}" dt="2021-12-11T14:52:57.588" v="364" actId="478"/>
          <ac:spMkLst>
            <pc:docMk/>
            <pc:sldMk cId="1061512908" sldId="259"/>
            <ac:spMk id="30" creationId="{9D18F01B-F547-45F8-826A-57EF6EE33173}"/>
          </ac:spMkLst>
        </pc:spChg>
        <pc:spChg chg="add del">
          <ac:chgData name="Hu Jintao" userId="6348392d7e799866" providerId="LiveId" clId="{68A9EE4A-F126-46C2-9F74-772F4EE693BA}" dt="2021-12-11T14:21:25.661" v="45" actId="26606"/>
          <ac:spMkLst>
            <pc:docMk/>
            <pc:sldMk cId="1061512908" sldId="259"/>
            <ac:spMk id="71" creationId="{743AA782-23D1-4521-8CAD-47662984AA08}"/>
          </ac:spMkLst>
        </pc:spChg>
        <pc:spChg chg="add del">
          <ac:chgData name="Hu Jintao" userId="6348392d7e799866" providerId="LiveId" clId="{68A9EE4A-F126-46C2-9F74-772F4EE693BA}" dt="2021-12-11T14:21:25.661" v="45" actId="26606"/>
          <ac:spMkLst>
            <pc:docMk/>
            <pc:sldMk cId="1061512908" sldId="259"/>
            <ac:spMk id="73" creationId="{650D18FE-0824-4A46-B22C-A86B52E5780A}"/>
          </ac:spMkLst>
        </pc:spChg>
        <pc:spChg chg="add">
          <ac:chgData name="Hu Jintao" userId="6348392d7e799866" providerId="LiveId" clId="{68A9EE4A-F126-46C2-9F74-772F4EE693BA}" dt="2021-12-11T14:21:25.661" v="45" actId="26606"/>
          <ac:spMkLst>
            <pc:docMk/>
            <pc:sldMk cId="1061512908" sldId="259"/>
            <ac:spMk id="78" creationId="{1B15ED52-F352-441B-82BF-E0EA34836D08}"/>
          </ac:spMkLst>
        </pc:spChg>
        <pc:spChg chg="add">
          <ac:chgData name="Hu Jintao" userId="6348392d7e799866" providerId="LiveId" clId="{68A9EE4A-F126-46C2-9F74-772F4EE693BA}" dt="2021-12-11T14:21:25.661" v="45" actId="26606"/>
          <ac:spMkLst>
            <pc:docMk/>
            <pc:sldMk cId="1061512908" sldId="259"/>
            <ac:spMk id="80" creationId="{61707E60-CEC9-4661-AA82-69242EB4BDC3}"/>
          </ac:spMkLst>
        </pc:spChg>
        <pc:spChg chg="add">
          <ac:chgData name="Hu Jintao" userId="6348392d7e799866" providerId="LiveId" clId="{68A9EE4A-F126-46C2-9F74-772F4EE693BA}" dt="2021-12-11T14:21:25.661" v="45" actId="26606"/>
          <ac:spMkLst>
            <pc:docMk/>
            <pc:sldMk cId="1061512908" sldId="259"/>
            <ac:spMk id="82" creationId="{8F035CD8-AE30-4146-96F2-036B0CE5E4F3}"/>
          </ac:spMkLst>
        </pc:spChg>
        <pc:grpChg chg="add mod ord">
          <ac:chgData name="Hu Jintao" userId="6348392d7e799866" providerId="LiveId" clId="{68A9EE4A-F126-46C2-9F74-772F4EE693BA}" dt="2021-12-11T14:43:53.792" v="238" actId="164"/>
          <ac:grpSpMkLst>
            <pc:docMk/>
            <pc:sldMk cId="1061512908" sldId="259"/>
            <ac:grpSpMk id="7" creationId="{CAC40EF9-4BB5-4A6C-9F4A-439718ABD3FE}"/>
          </ac:grpSpMkLst>
        </pc:grpChg>
        <pc:grpChg chg="add mod">
          <ac:chgData name="Hu Jintao" userId="6348392d7e799866" providerId="LiveId" clId="{68A9EE4A-F126-46C2-9F74-772F4EE693BA}" dt="2021-12-11T14:52:04.356" v="362" actId="1076"/>
          <ac:grpSpMkLst>
            <pc:docMk/>
            <pc:sldMk cId="1061512908" sldId="259"/>
            <ac:grpSpMk id="8" creationId="{CB86B16E-FA9F-4E6C-931E-9D874DA1EBC4}"/>
          </ac:grpSpMkLst>
        </pc:grpChg>
        <pc:grpChg chg="add mod ord">
          <ac:chgData name="Hu Jintao" userId="6348392d7e799866" providerId="LiveId" clId="{68A9EE4A-F126-46C2-9F74-772F4EE693BA}" dt="2021-12-11T14:43:53.792" v="238" actId="164"/>
          <ac:grpSpMkLst>
            <pc:docMk/>
            <pc:sldMk cId="1061512908" sldId="259"/>
            <ac:grpSpMk id="16" creationId="{A17C25C4-0630-4674-B49D-4D04D6F52D65}"/>
          </ac:grpSpMkLst>
        </pc:grpChg>
        <pc:grpChg chg="add mod">
          <ac:chgData name="Hu Jintao" userId="6348392d7e799866" providerId="LiveId" clId="{68A9EE4A-F126-46C2-9F74-772F4EE693BA}" dt="2021-12-11T14:43:53.792" v="238" actId="164"/>
          <ac:grpSpMkLst>
            <pc:docMk/>
            <pc:sldMk cId="1061512908" sldId="259"/>
            <ac:grpSpMk id="19" creationId="{678FD15E-37CB-4566-99CA-C2EA3534E7BF}"/>
          </ac:grpSpMkLst>
        </pc:grpChg>
        <pc:grpChg chg="add mod">
          <ac:chgData name="Hu Jintao" userId="6348392d7e799866" providerId="LiveId" clId="{68A9EE4A-F126-46C2-9F74-772F4EE693BA}" dt="2021-12-11T14:43:53.792" v="238" actId="164"/>
          <ac:grpSpMkLst>
            <pc:docMk/>
            <pc:sldMk cId="1061512908" sldId="259"/>
            <ac:grpSpMk id="22" creationId="{EC059290-0B2C-438A-9014-8B9444DA3ECB}"/>
          </ac:grpSpMkLst>
        </pc:grpChg>
        <pc:grpChg chg="add mod">
          <ac:chgData name="Hu Jintao" userId="6348392d7e799866" providerId="LiveId" clId="{68A9EE4A-F126-46C2-9F74-772F4EE693BA}" dt="2021-12-11T14:43:53.792" v="238" actId="164"/>
          <ac:grpSpMkLst>
            <pc:docMk/>
            <pc:sldMk cId="1061512908" sldId="259"/>
            <ac:grpSpMk id="25" creationId="{435C469C-9346-4510-AE78-0AA0F267B733}"/>
          </ac:grpSpMkLst>
        </pc:grpChg>
        <pc:grpChg chg="add del mod">
          <ac:chgData name="Hu Jintao" userId="6348392d7e799866" providerId="LiveId" clId="{68A9EE4A-F126-46C2-9F74-772F4EE693BA}" dt="2021-12-11T14:52:54.727" v="363" actId="478"/>
          <ac:grpSpMkLst>
            <pc:docMk/>
            <pc:sldMk cId="1061512908" sldId="259"/>
            <ac:grpSpMk id="28" creationId="{246386B8-1A56-4265-BC7F-96E8C578E735}"/>
          </ac:grpSpMkLst>
        </pc:grpChg>
        <pc:picChg chg="add del mod">
          <ac:chgData name="Hu Jintao" userId="6348392d7e799866" providerId="LiveId" clId="{68A9EE4A-F126-46C2-9F74-772F4EE693BA}" dt="2021-12-11T14:37:27.301" v="173" actId="478"/>
          <ac:picMkLst>
            <pc:docMk/>
            <pc:sldMk cId="1061512908" sldId="259"/>
            <ac:picMk id="2" creationId="{C959D47A-7E70-4E74-93D2-6C1F278AD650}"/>
          </ac:picMkLst>
        </pc:picChg>
        <pc:picChg chg="add del mod">
          <ac:chgData name="Hu Jintao" userId="6348392d7e799866" providerId="LiveId" clId="{68A9EE4A-F126-46C2-9F74-772F4EE693BA}" dt="2021-12-11T14:34:44.770" v="137" actId="478"/>
          <ac:picMkLst>
            <pc:docMk/>
            <pc:sldMk cId="1061512908" sldId="259"/>
            <ac:picMk id="6" creationId="{75C0935C-521D-41B7-B91A-6AA4B018F379}"/>
          </ac:picMkLst>
        </pc:picChg>
        <pc:picChg chg="del">
          <ac:chgData name="Hu Jintao" userId="6348392d7e799866" providerId="LiveId" clId="{68A9EE4A-F126-46C2-9F74-772F4EE693BA}" dt="2021-12-11T06:39:23.818" v="0" actId="478"/>
          <ac:picMkLst>
            <pc:docMk/>
            <pc:sldMk cId="1061512908" sldId="259"/>
            <ac:picMk id="8" creationId="{9AAE02E1-C24B-4E71-8A88-1B2BA4FE10CA}"/>
          </ac:picMkLst>
        </pc:picChg>
        <pc:picChg chg="add mod modCrop">
          <ac:chgData name="Hu Jintao" userId="6348392d7e799866" providerId="LiveId" clId="{68A9EE4A-F126-46C2-9F74-772F4EE693BA}" dt="2021-12-11T14:43:53.792" v="238" actId="164"/>
          <ac:picMkLst>
            <pc:docMk/>
            <pc:sldMk cId="1061512908" sldId="259"/>
            <ac:picMk id="13" creationId="{0E9BDC88-042F-4A52-9588-3327AAD40465}"/>
          </ac:picMkLst>
        </pc:picChg>
        <pc:picChg chg="add del mod">
          <ac:chgData name="Hu Jintao" userId="6348392d7e799866" providerId="LiveId" clId="{68A9EE4A-F126-46C2-9F74-772F4EE693BA}" dt="2021-12-11T14:21:14.019" v="43" actId="478"/>
          <ac:picMkLst>
            <pc:docMk/>
            <pc:sldMk cId="1061512908" sldId="259"/>
            <ac:picMk id="1026" creationId="{5F8AF9CA-0136-4433-9281-7791FF7BA5D4}"/>
          </ac:picMkLst>
        </pc:picChg>
      </pc:sldChg>
    </pc:docChg>
  </pc:docChgLst>
  <pc:docChgLst>
    <pc:chgData name="Hu Jintao" userId="6348392d7e799866" providerId="LiveId" clId="{AA384ADC-3BC1-43E8-957E-136DADB94FBD}"/>
    <pc:docChg chg="custSel modSld">
      <pc:chgData name="Hu Jintao" userId="6348392d7e799866" providerId="LiveId" clId="{AA384ADC-3BC1-43E8-957E-136DADB94FBD}" dt="2021-12-29T12:22:22.286" v="14" actId="113"/>
      <pc:docMkLst>
        <pc:docMk/>
      </pc:docMkLst>
      <pc:sldChg chg="delSp modSp mod">
        <pc:chgData name="Hu Jintao" userId="6348392d7e799866" providerId="LiveId" clId="{AA384ADC-3BC1-43E8-957E-136DADB94FBD}" dt="2021-12-29T12:22:22.286" v="14" actId="113"/>
        <pc:sldMkLst>
          <pc:docMk/>
          <pc:sldMk cId="1061512908" sldId="259"/>
        </pc:sldMkLst>
        <pc:spChg chg="del">
          <ac:chgData name="Hu Jintao" userId="6348392d7e799866" providerId="LiveId" clId="{AA384ADC-3BC1-43E8-957E-136DADB94FBD}" dt="2021-12-29T12:21:46.833" v="1" actId="478"/>
          <ac:spMkLst>
            <pc:docMk/>
            <pc:sldMk cId="1061512908" sldId="259"/>
            <ac:spMk id="3" creationId="{66DCADF2-0369-4DC2-A75D-C5DE6F2EBF44}"/>
          </ac:spMkLst>
        </pc:spChg>
        <pc:spChg chg="mod">
          <ac:chgData name="Hu Jintao" userId="6348392d7e799866" providerId="LiveId" clId="{AA384ADC-3BC1-43E8-957E-136DADB94FBD}" dt="2021-12-29T12:22:22.286" v="14" actId="113"/>
          <ac:spMkLst>
            <pc:docMk/>
            <pc:sldMk cId="1061512908" sldId="259"/>
            <ac:spMk id="4" creationId="{B4DC734E-AEA2-4910-8CC6-30EC42027CD5}"/>
          </ac:spMkLst>
        </pc:spChg>
        <pc:spChg chg="del">
          <ac:chgData name="Hu Jintao" userId="6348392d7e799866" providerId="LiveId" clId="{AA384ADC-3BC1-43E8-957E-136DADB94FBD}" dt="2021-12-29T12:21:44.097" v="0" actId="478"/>
          <ac:spMkLst>
            <pc:docMk/>
            <pc:sldMk cId="1061512908" sldId="259"/>
            <ac:spMk id="5" creationId="{32984EB3-9256-425C-B61F-99D39A23543B}"/>
          </ac:spMkLst>
        </pc:spChg>
        <pc:spChg chg="del">
          <ac:chgData name="Hu Jintao" userId="6348392d7e799866" providerId="LiveId" clId="{AA384ADC-3BC1-43E8-957E-136DADB94FBD}" dt="2021-12-29T12:21:50.315" v="3" actId="478"/>
          <ac:spMkLst>
            <pc:docMk/>
            <pc:sldMk cId="1061512908" sldId="259"/>
            <ac:spMk id="17" creationId="{BC0ACBB3-D658-40E6-8F7E-7D70CFF4DE2F}"/>
          </ac:spMkLst>
        </pc:spChg>
        <pc:spChg chg="del">
          <ac:chgData name="Hu Jintao" userId="6348392d7e799866" providerId="LiveId" clId="{AA384ADC-3BC1-43E8-957E-136DADB94FBD}" dt="2021-12-29T12:21:48.448" v="2" actId="478"/>
          <ac:spMkLst>
            <pc:docMk/>
            <pc:sldMk cId="1061512908" sldId="259"/>
            <ac:spMk id="18" creationId="{6DAA72A1-08FA-4AFF-A9D4-B6A859A8DBC9}"/>
          </ac:spMkLst>
        </pc:spChg>
        <pc:spChg chg="del topLvl">
          <ac:chgData name="Hu Jintao" userId="6348392d7e799866" providerId="LiveId" clId="{AA384ADC-3BC1-43E8-957E-136DADB94FBD}" dt="2021-12-29T12:22:00.110" v="9" actId="478"/>
          <ac:spMkLst>
            <pc:docMk/>
            <pc:sldMk cId="1061512908" sldId="259"/>
            <ac:spMk id="20" creationId="{0E888F3C-08E8-460D-8FBD-FC034EB0C1D2}"/>
          </ac:spMkLst>
        </pc:spChg>
        <pc:spChg chg="del">
          <ac:chgData name="Hu Jintao" userId="6348392d7e799866" providerId="LiveId" clId="{AA384ADC-3BC1-43E8-957E-136DADB94FBD}" dt="2021-12-29T12:21:58.362" v="8" actId="478"/>
          <ac:spMkLst>
            <pc:docMk/>
            <pc:sldMk cId="1061512908" sldId="259"/>
            <ac:spMk id="21" creationId="{9AD14D92-00BD-45AA-9EC6-6FB0FB86074F}"/>
          </ac:spMkLst>
        </pc:spChg>
        <pc:spChg chg="del">
          <ac:chgData name="Hu Jintao" userId="6348392d7e799866" providerId="LiveId" clId="{AA384ADC-3BC1-43E8-957E-136DADB94FBD}" dt="2021-12-29T12:21:53.723" v="5" actId="478"/>
          <ac:spMkLst>
            <pc:docMk/>
            <pc:sldMk cId="1061512908" sldId="259"/>
            <ac:spMk id="23" creationId="{6B392938-075D-4FD7-8348-277F26317784}"/>
          </ac:spMkLst>
        </pc:spChg>
        <pc:spChg chg="del">
          <ac:chgData name="Hu Jintao" userId="6348392d7e799866" providerId="LiveId" clId="{AA384ADC-3BC1-43E8-957E-136DADB94FBD}" dt="2021-12-29T12:21:52.105" v="4" actId="478"/>
          <ac:spMkLst>
            <pc:docMk/>
            <pc:sldMk cId="1061512908" sldId="259"/>
            <ac:spMk id="24" creationId="{D867CA17-BE28-466D-A251-E7D9C1B028A4}"/>
          </ac:spMkLst>
        </pc:spChg>
        <pc:spChg chg="del">
          <ac:chgData name="Hu Jintao" userId="6348392d7e799866" providerId="LiveId" clId="{AA384ADC-3BC1-43E8-957E-136DADB94FBD}" dt="2021-12-29T12:21:56.815" v="7" actId="478"/>
          <ac:spMkLst>
            <pc:docMk/>
            <pc:sldMk cId="1061512908" sldId="259"/>
            <ac:spMk id="26" creationId="{6F096459-40A1-46BD-8C1D-FAEE1A46759D}"/>
          </ac:spMkLst>
        </pc:spChg>
        <pc:spChg chg="del">
          <ac:chgData name="Hu Jintao" userId="6348392d7e799866" providerId="LiveId" clId="{AA384ADC-3BC1-43E8-957E-136DADB94FBD}" dt="2021-12-29T12:21:55.201" v="6" actId="478"/>
          <ac:spMkLst>
            <pc:docMk/>
            <pc:sldMk cId="1061512908" sldId="259"/>
            <ac:spMk id="27" creationId="{BF3DFD59-3CC0-4926-9A8D-64E4A31B5537}"/>
          </ac:spMkLst>
        </pc:spChg>
        <pc:grpChg chg="del">
          <ac:chgData name="Hu Jintao" userId="6348392d7e799866" providerId="LiveId" clId="{AA384ADC-3BC1-43E8-957E-136DADB94FBD}" dt="2021-12-29T12:21:44.097" v="0" actId="478"/>
          <ac:grpSpMkLst>
            <pc:docMk/>
            <pc:sldMk cId="1061512908" sldId="259"/>
            <ac:grpSpMk id="7" creationId="{CAC40EF9-4BB5-4A6C-9F4A-439718ABD3FE}"/>
          </ac:grpSpMkLst>
        </pc:grpChg>
        <pc:grpChg chg="del">
          <ac:chgData name="Hu Jintao" userId="6348392d7e799866" providerId="LiveId" clId="{AA384ADC-3BC1-43E8-957E-136DADB94FBD}" dt="2021-12-29T12:22:00.110" v="9" actId="478"/>
          <ac:grpSpMkLst>
            <pc:docMk/>
            <pc:sldMk cId="1061512908" sldId="259"/>
            <ac:grpSpMk id="8" creationId="{CB86B16E-FA9F-4E6C-931E-9D874DA1EBC4}"/>
          </ac:grpSpMkLst>
        </pc:grpChg>
        <pc:grpChg chg="del">
          <ac:chgData name="Hu Jintao" userId="6348392d7e799866" providerId="LiveId" clId="{AA384ADC-3BC1-43E8-957E-136DADB94FBD}" dt="2021-12-29T12:21:48.448" v="2" actId="478"/>
          <ac:grpSpMkLst>
            <pc:docMk/>
            <pc:sldMk cId="1061512908" sldId="259"/>
            <ac:grpSpMk id="16" creationId="{A17C25C4-0630-4674-B49D-4D04D6F52D65}"/>
          </ac:grpSpMkLst>
        </pc:grpChg>
        <pc:grpChg chg="del">
          <ac:chgData name="Hu Jintao" userId="6348392d7e799866" providerId="LiveId" clId="{AA384ADC-3BC1-43E8-957E-136DADB94FBD}" dt="2021-12-29T12:21:58.362" v="8" actId="478"/>
          <ac:grpSpMkLst>
            <pc:docMk/>
            <pc:sldMk cId="1061512908" sldId="259"/>
            <ac:grpSpMk id="19" creationId="{678FD15E-37CB-4566-99CA-C2EA3534E7BF}"/>
          </ac:grpSpMkLst>
        </pc:grpChg>
        <pc:grpChg chg="del">
          <ac:chgData name="Hu Jintao" userId="6348392d7e799866" providerId="LiveId" clId="{AA384ADC-3BC1-43E8-957E-136DADB94FBD}" dt="2021-12-29T12:21:52.105" v="4" actId="478"/>
          <ac:grpSpMkLst>
            <pc:docMk/>
            <pc:sldMk cId="1061512908" sldId="259"/>
            <ac:grpSpMk id="22" creationId="{EC059290-0B2C-438A-9014-8B9444DA3ECB}"/>
          </ac:grpSpMkLst>
        </pc:grpChg>
        <pc:grpChg chg="del">
          <ac:chgData name="Hu Jintao" userId="6348392d7e799866" providerId="LiveId" clId="{AA384ADC-3BC1-43E8-957E-136DADB94FBD}" dt="2021-12-29T12:21:55.201" v="6" actId="478"/>
          <ac:grpSpMkLst>
            <pc:docMk/>
            <pc:sldMk cId="1061512908" sldId="259"/>
            <ac:grpSpMk id="25" creationId="{435C469C-9346-4510-AE78-0AA0F267B733}"/>
          </ac:grpSpMkLst>
        </pc:grpChg>
        <pc:picChg chg="topLvl">
          <ac:chgData name="Hu Jintao" userId="6348392d7e799866" providerId="LiveId" clId="{AA384ADC-3BC1-43E8-957E-136DADB94FBD}" dt="2021-12-29T12:22:00.110" v="9" actId="478"/>
          <ac:picMkLst>
            <pc:docMk/>
            <pc:sldMk cId="1061512908" sldId="259"/>
            <ac:picMk id="13" creationId="{0E9BDC88-042F-4A52-9588-3327AAD40465}"/>
          </ac:picMkLst>
        </pc:picChg>
      </pc:sldChg>
    </pc:docChg>
  </pc:docChgLst>
  <pc:docChgLst>
    <pc:chgData name="Hu Jintao" userId="6348392d7e799866" providerId="LiveId" clId="{4DCA9083-E3B2-41E7-8302-C1ED8EF72D86}"/>
    <pc:docChg chg="delSld">
      <pc:chgData name="Hu Jintao" userId="6348392d7e799866" providerId="LiveId" clId="{4DCA9083-E3B2-41E7-8302-C1ED8EF72D86}" dt="2021-12-08T14:47:19.933" v="0" actId="2696"/>
      <pc:docMkLst>
        <pc:docMk/>
      </pc:docMkLst>
      <pc:sldChg chg="del">
        <pc:chgData name="Hu Jintao" userId="6348392d7e799866" providerId="LiveId" clId="{4DCA9083-E3B2-41E7-8302-C1ED8EF72D86}" dt="2021-12-08T14:47:19.933" v="0" actId="2696"/>
        <pc:sldMkLst>
          <pc:docMk/>
          <pc:sldMk cId="2405800400" sldId="260"/>
        </pc:sldMkLst>
      </pc:sldChg>
      <pc:sldChg chg="del">
        <pc:chgData name="Hu Jintao" userId="6348392d7e799866" providerId="LiveId" clId="{4DCA9083-E3B2-41E7-8302-C1ED8EF72D86}" dt="2021-12-08T14:47:19.933" v="0" actId="2696"/>
        <pc:sldMkLst>
          <pc:docMk/>
          <pc:sldMk cId="532015322" sldId="261"/>
        </pc:sldMkLst>
      </pc:sldChg>
      <pc:sldChg chg="del">
        <pc:chgData name="Hu Jintao" userId="6348392d7e799866" providerId="LiveId" clId="{4DCA9083-E3B2-41E7-8302-C1ED8EF72D86}" dt="2021-12-08T14:47:19.933" v="0" actId="2696"/>
        <pc:sldMkLst>
          <pc:docMk/>
          <pc:sldMk cId="2331998801" sldId="262"/>
        </pc:sldMkLst>
      </pc:sldChg>
      <pc:sldChg chg="del">
        <pc:chgData name="Hu Jintao" userId="6348392d7e799866" providerId="LiveId" clId="{4DCA9083-E3B2-41E7-8302-C1ED8EF72D86}" dt="2021-12-08T14:47:19.933" v="0" actId="2696"/>
        <pc:sldMkLst>
          <pc:docMk/>
          <pc:sldMk cId="1100145045" sldId="278"/>
        </pc:sldMkLst>
      </pc:sldChg>
      <pc:sldChg chg="del">
        <pc:chgData name="Hu Jintao" userId="6348392d7e799866" providerId="LiveId" clId="{4DCA9083-E3B2-41E7-8302-C1ED8EF72D86}" dt="2021-12-08T14:47:19.933" v="0" actId="2696"/>
        <pc:sldMkLst>
          <pc:docMk/>
          <pc:sldMk cId="3444855192" sldId="279"/>
        </pc:sldMkLst>
      </pc:sldChg>
      <pc:sldChg chg="del">
        <pc:chgData name="Hu Jintao" userId="6348392d7e799866" providerId="LiveId" clId="{4DCA9083-E3B2-41E7-8302-C1ED8EF72D86}" dt="2021-12-08T14:47:19.933" v="0" actId="2696"/>
        <pc:sldMkLst>
          <pc:docMk/>
          <pc:sldMk cId="1822491261" sldId="280"/>
        </pc:sldMkLst>
      </pc:sldChg>
      <pc:sldChg chg="del">
        <pc:chgData name="Hu Jintao" userId="6348392d7e799866" providerId="LiveId" clId="{4DCA9083-E3B2-41E7-8302-C1ED8EF72D86}" dt="2021-12-08T14:47:19.933" v="0" actId="2696"/>
        <pc:sldMkLst>
          <pc:docMk/>
          <pc:sldMk cId="1454885300" sldId="281"/>
        </pc:sldMkLst>
      </pc:sldChg>
      <pc:sldChg chg="del">
        <pc:chgData name="Hu Jintao" userId="6348392d7e799866" providerId="LiveId" clId="{4DCA9083-E3B2-41E7-8302-C1ED8EF72D86}" dt="2021-12-08T14:47:19.933" v="0" actId="2696"/>
        <pc:sldMkLst>
          <pc:docMk/>
          <pc:sldMk cId="3759901795" sldId="282"/>
        </pc:sldMkLst>
      </pc:sldChg>
      <pc:sldChg chg="del">
        <pc:chgData name="Hu Jintao" userId="6348392d7e799866" providerId="LiveId" clId="{4DCA9083-E3B2-41E7-8302-C1ED8EF72D86}" dt="2021-12-08T14:47:19.933" v="0" actId="2696"/>
        <pc:sldMkLst>
          <pc:docMk/>
          <pc:sldMk cId="2758835469" sldId="283"/>
        </pc:sldMkLst>
      </pc:sldChg>
      <pc:sldChg chg="del">
        <pc:chgData name="Hu Jintao" userId="6348392d7e799866" providerId="LiveId" clId="{4DCA9083-E3B2-41E7-8302-C1ED8EF72D86}" dt="2021-12-08T14:47:19.933" v="0" actId="2696"/>
        <pc:sldMkLst>
          <pc:docMk/>
          <pc:sldMk cId="635313154" sldId="284"/>
        </pc:sldMkLst>
      </pc:sldChg>
      <pc:sldChg chg="del">
        <pc:chgData name="Hu Jintao" userId="6348392d7e799866" providerId="LiveId" clId="{4DCA9083-E3B2-41E7-8302-C1ED8EF72D86}" dt="2021-12-08T14:47:19.933" v="0" actId="2696"/>
        <pc:sldMkLst>
          <pc:docMk/>
          <pc:sldMk cId="716670848" sldId="285"/>
        </pc:sldMkLst>
      </pc:sldChg>
      <pc:sldChg chg="del">
        <pc:chgData name="Hu Jintao" userId="6348392d7e799866" providerId="LiveId" clId="{4DCA9083-E3B2-41E7-8302-C1ED8EF72D86}" dt="2021-12-08T14:47:19.933" v="0" actId="2696"/>
        <pc:sldMkLst>
          <pc:docMk/>
          <pc:sldMk cId="1998506731" sldId="286"/>
        </pc:sldMkLst>
      </pc:sldChg>
      <pc:sldChg chg="del">
        <pc:chgData name="Hu Jintao" userId="6348392d7e799866" providerId="LiveId" clId="{4DCA9083-E3B2-41E7-8302-C1ED8EF72D86}" dt="2021-12-08T14:47:19.933" v="0" actId="2696"/>
        <pc:sldMkLst>
          <pc:docMk/>
          <pc:sldMk cId="589716146" sldId="287"/>
        </pc:sldMkLst>
      </pc:sldChg>
      <pc:sldChg chg="del">
        <pc:chgData name="Hu Jintao" userId="6348392d7e799866" providerId="LiveId" clId="{4DCA9083-E3B2-41E7-8302-C1ED8EF72D86}" dt="2021-12-08T14:47:19.933" v="0" actId="2696"/>
        <pc:sldMkLst>
          <pc:docMk/>
          <pc:sldMk cId="202521556" sldId="288"/>
        </pc:sldMkLst>
      </pc:sldChg>
      <pc:sldChg chg="del">
        <pc:chgData name="Hu Jintao" userId="6348392d7e799866" providerId="LiveId" clId="{4DCA9083-E3B2-41E7-8302-C1ED8EF72D86}" dt="2021-12-08T14:47:19.933" v="0" actId="2696"/>
        <pc:sldMkLst>
          <pc:docMk/>
          <pc:sldMk cId="1245195150" sldId="289"/>
        </pc:sldMkLst>
      </pc:sldChg>
      <pc:sldChg chg="del">
        <pc:chgData name="Hu Jintao" userId="6348392d7e799866" providerId="LiveId" clId="{4DCA9083-E3B2-41E7-8302-C1ED8EF72D86}" dt="2021-12-08T14:47:19.933" v="0" actId="2696"/>
        <pc:sldMkLst>
          <pc:docMk/>
          <pc:sldMk cId="984096084" sldId="290"/>
        </pc:sldMkLst>
      </pc:sldChg>
      <pc:sldChg chg="del">
        <pc:chgData name="Hu Jintao" userId="6348392d7e799866" providerId="LiveId" clId="{4DCA9083-E3B2-41E7-8302-C1ED8EF72D86}" dt="2021-12-08T14:47:19.933" v="0" actId="2696"/>
        <pc:sldMkLst>
          <pc:docMk/>
          <pc:sldMk cId="1790763691" sldId="291"/>
        </pc:sldMkLst>
      </pc:sldChg>
      <pc:sldChg chg="del">
        <pc:chgData name="Hu Jintao" userId="6348392d7e799866" providerId="LiveId" clId="{4DCA9083-E3B2-41E7-8302-C1ED8EF72D86}" dt="2021-12-08T14:47:19.933" v="0" actId="2696"/>
        <pc:sldMkLst>
          <pc:docMk/>
          <pc:sldMk cId="2307115746" sldId="292"/>
        </pc:sldMkLst>
      </pc:sldChg>
      <pc:sldChg chg="del">
        <pc:chgData name="Hu Jintao" userId="6348392d7e799866" providerId="LiveId" clId="{4DCA9083-E3B2-41E7-8302-C1ED8EF72D86}" dt="2021-12-08T14:47:19.933" v="0" actId="2696"/>
        <pc:sldMkLst>
          <pc:docMk/>
          <pc:sldMk cId="1314342839" sldId="293"/>
        </pc:sldMkLst>
      </pc:sldChg>
      <pc:sldChg chg="del">
        <pc:chgData name="Hu Jintao" userId="6348392d7e799866" providerId="LiveId" clId="{4DCA9083-E3B2-41E7-8302-C1ED8EF72D86}" dt="2021-12-08T14:47:19.933" v="0" actId="2696"/>
        <pc:sldMkLst>
          <pc:docMk/>
          <pc:sldMk cId="3896388846" sldId="294"/>
        </pc:sldMkLst>
      </pc:sldChg>
      <pc:sldChg chg="del">
        <pc:chgData name="Hu Jintao" userId="6348392d7e799866" providerId="LiveId" clId="{4DCA9083-E3B2-41E7-8302-C1ED8EF72D86}" dt="2021-12-08T14:47:19.933" v="0" actId="2696"/>
        <pc:sldMkLst>
          <pc:docMk/>
          <pc:sldMk cId="761743600" sldId="295"/>
        </pc:sldMkLst>
      </pc:sldChg>
      <pc:sldChg chg="del">
        <pc:chgData name="Hu Jintao" userId="6348392d7e799866" providerId="LiveId" clId="{4DCA9083-E3B2-41E7-8302-C1ED8EF72D86}" dt="2021-12-08T14:47:19.933" v="0" actId="2696"/>
        <pc:sldMkLst>
          <pc:docMk/>
          <pc:sldMk cId="728547010" sldId="296"/>
        </pc:sldMkLst>
      </pc:sldChg>
      <pc:sldChg chg="del">
        <pc:chgData name="Hu Jintao" userId="6348392d7e799866" providerId="LiveId" clId="{4DCA9083-E3B2-41E7-8302-C1ED8EF72D86}" dt="2021-12-08T14:47:19.933" v="0" actId="2696"/>
        <pc:sldMkLst>
          <pc:docMk/>
          <pc:sldMk cId="1618709185" sldId="299"/>
        </pc:sldMkLst>
      </pc:sldChg>
      <pc:sldChg chg="del">
        <pc:chgData name="Hu Jintao" userId="6348392d7e799866" providerId="LiveId" clId="{4DCA9083-E3B2-41E7-8302-C1ED8EF72D86}" dt="2021-12-08T14:47:19.933" v="0" actId="2696"/>
        <pc:sldMkLst>
          <pc:docMk/>
          <pc:sldMk cId="66692680" sldId="300"/>
        </pc:sldMkLst>
      </pc:sldChg>
      <pc:sldChg chg="del">
        <pc:chgData name="Hu Jintao" userId="6348392d7e799866" providerId="LiveId" clId="{4DCA9083-E3B2-41E7-8302-C1ED8EF72D86}" dt="2021-12-08T14:47:19.933" v="0" actId="2696"/>
        <pc:sldMkLst>
          <pc:docMk/>
          <pc:sldMk cId="355850547" sldId="30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E2C2625-6333-4F4D-B1C4-E35403D946C0}" type="datetimeFigureOut">
              <a:rPr kumimoji="1" lang="zh-CN" altLang="en-US" smtClean="0"/>
              <a:t>2021/12/29</a:t>
            </a:fld>
            <a:endParaRPr kumimoji="1"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18FA5D3-8CF4-4542-A217-B5C8C1D82939}" type="slidenum">
              <a:rPr kumimoji="1" lang="zh-CN" altLang="en-US" smtClean="0"/>
              <a:t>‹#›</a:t>
            </a:fld>
            <a:endParaRPr kumimoji="1" lang="zh-CN" altLang="en-US"/>
          </a:p>
        </p:txBody>
      </p:sp>
    </p:spTree>
    <p:extLst>
      <p:ext uri="{BB962C8B-B14F-4D97-AF65-F5344CB8AC3E}">
        <p14:creationId xmlns:p14="http://schemas.microsoft.com/office/powerpoint/2010/main" val="28420331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618FA5D3-8CF4-4542-A217-B5C8C1D82939}" type="slidenum">
              <a:rPr kumimoji="1" lang="zh-CN" altLang="en-US" smtClean="0"/>
              <a:t>1</a:t>
            </a:fld>
            <a:endParaRPr kumimoji="1" lang="zh-CN" altLang="en-US"/>
          </a:p>
        </p:txBody>
      </p:sp>
    </p:spTree>
    <p:extLst>
      <p:ext uri="{BB962C8B-B14F-4D97-AF65-F5344CB8AC3E}">
        <p14:creationId xmlns:p14="http://schemas.microsoft.com/office/powerpoint/2010/main" val="1013656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5EEB756-7B8F-3A45-AF46-FDE794184532}"/>
              </a:ext>
            </a:extLst>
          </p:cNvPr>
          <p:cNvSpPr>
            <a:spLocks noGrp="1"/>
          </p:cNvSpPr>
          <p:nvPr>
            <p:ph type="ctrTitle"/>
          </p:nvPr>
        </p:nvSpPr>
        <p:spPr>
          <a:xfrm>
            <a:off x="1524000" y="1122363"/>
            <a:ext cx="9144000" cy="2387600"/>
          </a:xfrm>
        </p:spPr>
        <p:txBody>
          <a:bodyPr anchor="b"/>
          <a:lstStyle>
            <a:lvl1pPr algn="ctr">
              <a:defRPr sz="6000"/>
            </a:lvl1pPr>
          </a:lstStyle>
          <a:p>
            <a:r>
              <a:rPr kumimoji="1" lang="zh-CN" altLang="en-US"/>
              <a:t>单击此处编辑母版标题样式</a:t>
            </a:r>
          </a:p>
        </p:txBody>
      </p:sp>
      <p:sp>
        <p:nvSpPr>
          <p:cNvPr id="3" name="副标题 2">
            <a:extLst>
              <a:ext uri="{FF2B5EF4-FFF2-40B4-BE49-F238E27FC236}">
                <a16:creationId xmlns:a16="http://schemas.microsoft.com/office/drawing/2014/main" id="{E76FD958-1421-F547-AA86-52351C9ADFF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CN" altLang="en-US"/>
              <a:t>单击此处编辑母版副标题样式</a:t>
            </a:r>
          </a:p>
        </p:txBody>
      </p:sp>
      <p:sp>
        <p:nvSpPr>
          <p:cNvPr id="4" name="日期占位符 3">
            <a:extLst>
              <a:ext uri="{FF2B5EF4-FFF2-40B4-BE49-F238E27FC236}">
                <a16:creationId xmlns:a16="http://schemas.microsoft.com/office/drawing/2014/main" id="{61C96F23-EEED-1248-89FA-3039107D4219}"/>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ADE8A7A7-E18C-5D4B-9B6C-1D892F4588DE}"/>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9CC25497-5FC4-4C4D-909D-C0D9A24B1D2F}"/>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21431494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CCD7C38-4139-8F40-A22D-9E126CB4589D}"/>
              </a:ext>
            </a:extLst>
          </p:cNvPr>
          <p:cNvSpPr>
            <a:spLocks noGrp="1"/>
          </p:cNvSpPr>
          <p:nvPr>
            <p:ph type="title"/>
          </p:nvPr>
        </p:nvSpPr>
        <p:spPr/>
        <p:txBody>
          <a:bodyPr/>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C57420FC-F141-8340-BACC-0E743333E58F}"/>
              </a:ext>
            </a:extLst>
          </p:cNvPr>
          <p:cNvSpPr>
            <a:spLocks noGrp="1"/>
          </p:cNvSpPr>
          <p:nvPr>
            <p:ph type="body" orient="vert" idx="1"/>
          </p:nvPr>
        </p:nvSpPr>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D65E02C2-6755-1847-91C5-61C1BF495A1B}"/>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8B8DA703-BA84-F042-B6D3-05A96A0F5ADD}"/>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DF463398-FC35-4540-8845-4AAD67FF3B2D}"/>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25148922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B2F90F4F-47B3-4347-B3B2-918A257C8BA7}"/>
              </a:ext>
            </a:extLst>
          </p:cNvPr>
          <p:cNvSpPr>
            <a:spLocks noGrp="1"/>
          </p:cNvSpPr>
          <p:nvPr>
            <p:ph type="title" orient="vert"/>
          </p:nvPr>
        </p:nvSpPr>
        <p:spPr>
          <a:xfrm>
            <a:off x="8724900" y="365125"/>
            <a:ext cx="2628900" cy="5811838"/>
          </a:xfrm>
        </p:spPr>
        <p:txBody>
          <a:bodyPr vert="eaVert"/>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C152A417-EC2F-CD47-91B4-91C4BC0F917A}"/>
              </a:ext>
            </a:extLst>
          </p:cNvPr>
          <p:cNvSpPr>
            <a:spLocks noGrp="1"/>
          </p:cNvSpPr>
          <p:nvPr>
            <p:ph type="body" orient="vert" idx="1"/>
          </p:nvPr>
        </p:nvSpPr>
        <p:spPr>
          <a:xfrm>
            <a:off x="838200" y="365125"/>
            <a:ext cx="7734300" cy="5811838"/>
          </a:xfrm>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9E8895AC-58A0-9E45-93CC-56483EDC9B66}"/>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4A48CEA6-D2F8-9841-A1C7-B2D3A87BE849}"/>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B1354590-A980-C34D-BDB6-5A3638E28345}"/>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18025891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1652302-9520-484D-814F-C89819FD5D05}"/>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39E07A74-27D8-B94A-A880-54BC3DC9909C}"/>
              </a:ext>
            </a:extLst>
          </p:cNvPr>
          <p:cNvSpPr>
            <a:spLocks noGrp="1"/>
          </p:cNvSpPr>
          <p:nvPr>
            <p:ph idx="1"/>
          </p:nvPr>
        </p:nvSpPr>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E1ACFFD1-59CE-494E-84BF-D360CBC11534}"/>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780377A4-09B6-B646-BA52-2E6ADAA7290F}"/>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5CBE1EF2-4ECD-214A-8654-1F6505819F71}"/>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36458821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181F45B-5F07-9C46-B606-8D637D58C873}"/>
              </a:ext>
            </a:extLst>
          </p:cNvPr>
          <p:cNvSpPr>
            <a:spLocks noGrp="1"/>
          </p:cNvSpPr>
          <p:nvPr>
            <p:ph type="title"/>
          </p:nvPr>
        </p:nvSpPr>
        <p:spPr>
          <a:xfrm>
            <a:off x="831850" y="1709738"/>
            <a:ext cx="10515600" cy="2852737"/>
          </a:xfrm>
        </p:spPr>
        <p:txBody>
          <a:bodyPr anchor="b"/>
          <a:lstStyle>
            <a:lvl1pPr>
              <a:defRPr sz="6000"/>
            </a:lvl1pPr>
          </a:lstStyle>
          <a:p>
            <a:r>
              <a:rPr kumimoji="1" lang="zh-CN" altLang="en-US"/>
              <a:t>单击此处编辑母版标题样式</a:t>
            </a:r>
          </a:p>
        </p:txBody>
      </p:sp>
      <p:sp>
        <p:nvSpPr>
          <p:cNvPr id="3" name="文本占位符 2">
            <a:extLst>
              <a:ext uri="{FF2B5EF4-FFF2-40B4-BE49-F238E27FC236}">
                <a16:creationId xmlns:a16="http://schemas.microsoft.com/office/drawing/2014/main" id="{0BF6EEA8-40B8-1744-9E50-8A096EA70DB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zh-CN" altLang="en-US"/>
              <a:t>单击此处编辑母版文本样式</a:t>
            </a:r>
          </a:p>
        </p:txBody>
      </p:sp>
      <p:sp>
        <p:nvSpPr>
          <p:cNvPr id="4" name="日期占位符 3">
            <a:extLst>
              <a:ext uri="{FF2B5EF4-FFF2-40B4-BE49-F238E27FC236}">
                <a16:creationId xmlns:a16="http://schemas.microsoft.com/office/drawing/2014/main" id="{72564AA0-F7BA-E74A-99C8-BD4A453141DA}"/>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3124786D-51BF-0244-B588-A99D980A5714}"/>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30050EDC-3EFF-724E-89BA-ABB04A4BEFC5}"/>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3331213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71E8A98-3D3D-AA48-8CA6-D3E9A2C4E062}"/>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193D4BD1-1880-4743-A6C4-4E1E910AE41F}"/>
              </a:ext>
            </a:extLst>
          </p:cNvPr>
          <p:cNvSpPr>
            <a:spLocks noGrp="1"/>
          </p:cNvSpPr>
          <p:nvPr>
            <p:ph sz="half" idx="1"/>
          </p:nvPr>
        </p:nvSpPr>
        <p:spPr>
          <a:xfrm>
            <a:off x="838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内容占位符 3">
            <a:extLst>
              <a:ext uri="{FF2B5EF4-FFF2-40B4-BE49-F238E27FC236}">
                <a16:creationId xmlns:a16="http://schemas.microsoft.com/office/drawing/2014/main" id="{A8D52BA8-8892-6D4D-8F17-A8BC83CD684E}"/>
              </a:ext>
            </a:extLst>
          </p:cNvPr>
          <p:cNvSpPr>
            <a:spLocks noGrp="1"/>
          </p:cNvSpPr>
          <p:nvPr>
            <p:ph sz="half" idx="2"/>
          </p:nvPr>
        </p:nvSpPr>
        <p:spPr>
          <a:xfrm>
            <a:off x="6172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日期占位符 4">
            <a:extLst>
              <a:ext uri="{FF2B5EF4-FFF2-40B4-BE49-F238E27FC236}">
                <a16:creationId xmlns:a16="http://schemas.microsoft.com/office/drawing/2014/main" id="{F0A64760-0FE7-F745-9576-BBF86FD21246}"/>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6" name="页脚占位符 5">
            <a:extLst>
              <a:ext uri="{FF2B5EF4-FFF2-40B4-BE49-F238E27FC236}">
                <a16:creationId xmlns:a16="http://schemas.microsoft.com/office/drawing/2014/main" id="{7F5AF20A-7D76-EE41-862D-2C8A5B1928D1}"/>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EBBB0103-71CD-E849-B3DA-42CC4D9E7D79}"/>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14731708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0CC0D5F-7917-B246-B57A-9DE919808373}"/>
              </a:ext>
            </a:extLst>
          </p:cNvPr>
          <p:cNvSpPr>
            <a:spLocks noGrp="1"/>
          </p:cNvSpPr>
          <p:nvPr>
            <p:ph type="title"/>
          </p:nvPr>
        </p:nvSpPr>
        <p:spPr>
          <a:xfrm>
            <a:off x="839788" y="365125"/>
            <a:ext cx="10515600" cy="1325563"/>
          </a:xfrm>
        </p:spPr>
        <p:txBody>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97B5E19E-C86E-5943-9D15-86E3196341A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4" name="内容占位符 3">
            <a:extLst>
              <a:ext uri="{FF2B5EF4-FFF2-40B4-BE49-F238E27FC236}">
                <a16:creationId xmlns:a16="http://schemas.microsoft.com/office/drawing/2014/main" id="{24E722D7-7DF2-144B-95B4-27EA0AFFA762}"/>
              </a:ext>
            </a:extLst>
          </p:cNvPr>
          <p:cNvSpPr>
            <a:spLocks noGrp="1"/>
          </p:cNvSpPr>
          <p:nvPr>
            <p:ph sz="half" idx="2"/>
          </p:nvPr>
        </p:nvSpPr>
        <p:spPr>
          <a:xfrm>
            <a:off x="839788" y="2505075"/>
            <a:ext cx="5157787"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文本占位符 4">
            <a:extLst>
              <a:ext uri="{FF2B5EF4-FFF2-40B4-BE49-F238E27FC236}">
                <a16:creationId xmlns:a16="http://schemas.microsoft.com/office/drawing/2014/main" id="{96E1862C-1ED3-114D-B54A-E5CBFA4F81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6" name="内容占位符 5">
            <a:extLst>
              <a:ext uri="{FF2B5EF4-FFF2-40B4-BE49-F238E27FC236}">
                <a16:creationId xmlns:a16="http://schemas.microsoft.com/office/drawing/2014/main" id="{D7FBB510-6F55-184F-9F59-09DF21B9E811}"/>
              </a:ext>
            </a:extLst>
          </p:cNvPr>
          <p:cNvSpPr>
            <a:spLocks noGrp="1"/>
          </p:cNvSpPr>
          <p:nvPr>
            <p:ph sz="quarter" idx="4"/>
          </p:nvPr>
        </p:nvSpPr>
        <p:spPr>
          <a:xfrm>
            <a:off x="6172200" y="2505075"/>
            <a:ext cx="5183188"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7" name="日期占位符 6">
            <a:extLst>
              <a:ext uri="{FF2B5EF4-FFF2-40B4-BE49-F238E27FC236}">
                <a16:creationId xmlns:a16="http://schemas.microsoft.com/office/drawing/2014/main" id="{A237FBBC-8B83-D248-AA53-20F618D3CAD2}"/>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8" name="页脚占位符 7">
            <a:extLst>
              <a:ext uri="{FF2B5EF4-FFF2-40B4-BE49-F238E27FC236}">
                <a16:creationId xmlns:a16="http://schemas.microsoft.com/office/drawing/2014/main" id="{C311FE1B-919A-FD4F-8678-5E2CDE00267F}"/>
              </a:ext>
            </a:extLst>
          </p:cNvPr>
          <p:cNvSpPr>
            <a:spLocks noGrp="1"/>
          </p:cNvSpPr>
          <p:nvPr>
            <p:ph type="ftr" sz="quarter" idx="11"/>
          </p:nvPr>
        </p:nvSpPr>
        <p:spPr/>
        <p:txBody>
          <a:bodyPr/>
          <a:lstStyle/>
          <a:p>
            <a:endParaRPr kumimoji="1" lang="zh-CN" altLang="en-US"/>
          </a:p>
        </p:txBody>
      </p:sp>
      <p:sp>
        <p:nvSpPr>
          <p:cNvPr id="9" name="灯片编号占位符 8">
            <a:extLst>
              <a:ext uri="{FF2B5EF4-FFF2-40B4-BE49-F238E27FC236}">
                <a16:creationId xmlns:a16="http://schemas.microsoft.com/office/drawing/2014/main" id="{FBFF2AF0-2711-4D46-931B-A068715B48B7}"/>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6292295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268E98D-DEFD-4E4A-8889-B51041FBB4E3}"/>
              </a:ext>
            </a:extLst>
          </p:cNvPr>
          <p:cNvSpPr>
            <a:spLocks noGrp="1"/>
          </p:cNvSpPr>
          <p:nvPr>
            <p:ph type="title"/>
          </p:nvPr>
        </p:nvSpPr>
        <p:spPr/>
        <p:txBody>
          <a:bodyPr/>
          <a:lstStyle/>
          <a:p>
            <a:r>
              <a:rPr kumimoji="1" lang="zh-CN" altLang="en-US"/>
              <a:t>单击此处编辑母版标题样式</a:t>
            </a:r>
          </a:p>
        </p:txBody>
      </p:sp>
      <p:sp>
        <p:nvSpPr>
          <p:cNvPr id="3" name="日期占位符 2">
            <a:extLst>
              <a:ext uri="{FF2B5EF4-FFF2-40B4-BE49-F238E27FC236}">
                <a16:creationId xmlns:a16="http://schemas.microsoft.com/office/drawing/2014/main" id="{546F8700-56AA-0C45-9E77-B90170AF0E04}"/>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4" name="页脚占位符 3">
            <a:extLst>
              <a:ext uri="{FF2B5EF4-FFF2-40B4-BE49-F238E27FC236}">
                <a16:creationId xmlns:a16="http://schemas.microsoft.com/office/drawing/2014/main" id="{1123F7E8-2EB0-5B46-B0A9-934DFC1EF3F1}"/>
              </a:ext>
            </a:extLst>
          </p:cNvPr>
          <p:cNvSpPr>
            <a:spLocks noGrp="1"/>
          </p:cNvSpPr>
          <p:nvPr>
            <p:ph type="ftr" sz="quarter" idx="11"/>
          </p:nvPr>
        </p:nvSpPr>
        <p:spPr/>
        <p:txBody>
          <a:bodyPr/>
          <a:lstStyle/>
          <a:p>
            <a:endParaRPr kumimoji="1" lang="zh-CN" altLang="en-US"/>
          </a:p>
        </p:txBody>
      </p:sp>
      <p:sp>
        <p:nvSpPr>
          <p:cNvPr id="5" name="灯片编号占位符 4">
            <a:extLst>
              <a:ext uri="{FF2B5EF4-FFF2-40B4-BE49-F238E27FC236}">
                <a16:creationId xmlns:a16="http://schemas.microsoft.com/office/drawing/2014/main" id="{DA24148E-8E33-874C-BB3D-1922AF55DD0C}"/>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17078278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E5D80D6E-338E-3843-852F-206C5D75FD45}"/>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3" name="页脚占位符 2">
            <a:extLst>
              <a:ext uri="{FF2B5EF4-FFF2-40B4-BE49-F238E27FC236}">
                <a16:creationId xmlns:a16="http://schemas.microsoft.com/office/drawing/2014/main" id="{1FF3B774-E254-6549-81D5-CACD3BBE13D0}"/>
              </a:ext>
            </a:extLst>
          </p:cNvPr>
          <p:cNvSpPr>
            <a:spLocks noGrp="1"/>
          </p:cNvSpPr>
          <p:nvPr>
            <p:ph type="ftr" sz="quarter" idx="11"/>
          </p:nvPr>
        </p:nvSpPr>
        <p:spPr/>
        <p:txBody>
          <a:bodyPr/>
          <a:lstStyle/>
          <a:p>
            <a:endParaRPr kumimoji="1" lang="zh-CN" altLang="en-US"/>
          </a:p>
        </p:txBody>
      </p:sp>
      <p:sp>
        <p:nvSpPr>
          <p:cNvPr id="4" name="灯片编号占位符 3">
            <a:extLst>
              <a:ext uri="{FF2B5EF4-FFF2-40B4-BE49-F238E27FC236}">
                <a16:creationId xmlns:a16="http://schemas.microsoft.com/office/drawing/2014/main" id="{F3FD4A22-6BA4-8640-90BD-AE693CE64CAD}"/>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28457959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A74DB9A-CFF2-0445-995E-873FCDD14D2C}"/>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内容占位符 2">
            <a:extLst>
              <a:ext uri="{FF2B5EF4-FFF2-40B4-BE49-F238E27FC236}">
                <a16:creationId xmlns:a16="http://schemas.microsoft.com/office/drawing/2014/main" id="{914D8297-F92A-334B-8AC7-4F77AB4B838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文本占位符 3">
            <a:extLst>
              <a:ext uri="{FF2B5EF4-FFF2-40B4-BE49-F238E27FC236}">
                <a16:creationId xmlns:a16="http://schemas.microsoft.com/office/drawing/2014/main" id="{7DEB396B-BA41-6F45-80DD-4455C60995C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6CF86EFC-F840-D64A-AFB5-5CA32C9A53B6}"/>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6" name="页脚占位符 5">
            <a:extLst>
              <a:ext uri="{FF2B5EF4-FFF2-40B4-BE49-F238E27FC236}">
                <a16:creationId xmlns:a16="http://schemas.microsoft.com/office/drawing/2014/main" id="{F64061A2-12F9-9640-8865-D04F0D0B9ADA}"/>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88FC4E51-6297-624D-B22F-73C7E118E989}"/>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20051180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449D9E8-F661-5A4A-9F57-30F2546847D1}"/>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图片占位符 2">
            <a:extLst>
              <a:ext uri="{FF2B5EF4-FFF2-40B4-BE49-F238E27FC236}">
                <a16:creationId xmlns:a16="http://schemas.microsoft.com/office/drawing/2014/main" id="{2F9AD5CB-75EE-B646-8E1E-9B5686509D5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a:extLst>
              <a:ext uri="{FF2B5EF4-FFF2-40B4-BE49-F238E27FC236}">
                <a16:creationId xmlns:a16="http://schemas.microsoft.com/office/drawing/2014/main" id="{A3C38F07-9210-2F47-B721-B738415637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83006475-7315-4C4D-B224-6F880699E8BF}"/>
              </a:ext>
            </a:extLst>
          </p:cNvPr>
          <p:cNvSpPr>
            <a:spLocks noGrp="1"/>
          </p:cNvSpPr>
          <p:nvPr>
            <p:ph type="dt" sz="half" idx="10"/>
          </p:nvPr>
        </p:nvSpPr>
        <p:spPr/>
        <p:txBody>
          <a:bodyPr/>
          <a:lstStyle/>
          <a:p>
            <a:fld id="{7505F56C-9EA9-8447-88EF-0231EEEFC279}" type="datetimeFigureOut">
              <a:rPr kumimoji="1" lang="zh-CN" altLang="en-US" smtClean="0"/>
              <a:t>2021/12/29</a:t>
            </a:fld>
            <a:endParaRPr kumimoji="1" lang="zh-CN" altLang="en-US"/>
          </a:p>
        </p:txBody>
      </p:sp>
      <p:sp>
        <p:nvSpPr>
          <p:cNvPr id="6" name="页脚占位符 5">
            <a:extLst>
              <a:ext uri="{FF2B5EF4-FFF2-40B4-BE49-F238E27FC236}">
                <a16:creationId xmlns:a16="http://schemas.microsoft.com/office/drawing/2014/main" id="{A61DAB49-EE54-A44B-9BC2-CF2BD39144EE}"/>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9B5D64D4-258F-7946-A3C0-339AD8ABD000}"/>
              </a:ext>
            </a:extLst>
          </p:cNvPr>
          <p:cNvSpPr>
            <a:spLocks noGrp="1"/>
          </p:cNvSpPr>
          <p:nvPr>
            <p:ph type="sldNum" sz="quarter" idx="12"/>
          </p:nvPr>
        </p:nvSpPr>
        <p:spPr/>
        <p:txBody>
          <a:body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7405365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0F80564B-D992-B142-8823-2048959E86A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0C579952-228D-6241-8893-202DB108259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E54A1318-D698-B248-906F-D1BA9B82382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05F56C-9EA9-8447-88EF-0231EEEFC279}" type="datetimeFigureOut">
              <a:rPr kumimoji="1" lang="zh-CN" altLang="en-US" smtClean="0"/>
              <a:t>2021/12/29</a:t>
            </a:fld>
            <a:endParaRPr kumimoji="1" lang="zh-CN" altLang="en-US"/>
          </a:p>
        </p:txBody>
      </p:sp>
      <p:sp>
        <p:nvSpPr>
          <p:cNvPr id="5" name="页脚占位符 4">
            <a:extLst>
              <a:ext uri="{FF2B5EF4-FFF2-40B4-BE49-F238E27FC236}">
                <a16:creationId xmlns:a16="http://schemas.microsoft.com/office/drawing/2014/main" id="{7DE79206-8152-8B40-9C25-5419A9B4BC0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灯片编号占位符 5">
            <a:extLst>
              <a:ext uri="{FF2B5EF4-FFF2-40B4-BE49-F238E27FC236}">
                <a16:creationId xmlns:a16="http://schemas.microsoft.com/office/drawing/2014/main" id="{9F1A3A74-C7A2-DC46-A362-30A47546EA4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771E0E2-BE26-E64E-9B0C-551DE75010AB}" type="slidenum">
              <a:rPr kumimoji="1" lang="zh-CN" altLang="en-US" smtClean="0"/>
              <a:t>‹#›</a:t>
            </a:fld>
            <a:endParaRPr kumimoji="1" lang="zh-CN" altLang="en-US"/>
          </a:p>
        </p:txBody>
      </p:sp>
    </p:spTree>
    <p:extLst>
      <p:ext uri="{BB962C8B-B14F-4D97-AF65-F5344CB8AC3E}">
        <p14:creationId xmlns:p14="http://schemas.microsoft.com/office/powerpoint/2010/main" val="17003331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8" name="Rectangle 77">
            <a:extLst>
              <a:ext uri="{FF2B5EF4-FFF2-40B4-BE49-F238E27FC236}">
                <a16:creationId xmlns:a16="http://schemas.microsoft.com/office/drawing/2014/main" id="{1B15ED52-F352-441B-82BF-E0EA34836D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内容占位符 3">
            <a:extLst>
              <a:ext uri="{FF2B5EF4-FFF2-40B4-BE49-F238E27FC236}">
                <a16:creationId xmlns:a16="http://schemas.microsoft.com/office/drawing/2014/main" id="{B4DC734E-AEA2-4910-8CC6-30EC42027CD5}"/>
              </a:ext>
            </a:extLst>
          </p:cNvPr>
          <p:cNvSpPr>
            <a:spLocks noGrp="1"/>
          </p:cNvSpPr>
          <p:nvPr>
            <p:ph idx="1"/>
          </p:nvPr>
        </p:nvSpPr>
        <p:spPr>
          <a:xfrm>
            <a:off x="166577" y="1499710"/>
            <a:ext cx="5929422" cy="3519780"/>
          </a:xfrm>
        </p:spPr>
        <p:txBody>
          <a:bodyPr vert="horz" lIns="91440" tIns="45720" rIns="91440" bIns="45720" rtlCol="0">
            <a:normAutofit/>
          </a:bodyPr>
          <a:lstStyle/>
          <a:p>
            <a:pPr algn="just"/>
            <a:r>
              <a:rPr lang="en-US" altLang="zh-CN" sz="1400" b="1" dirty="0">
                <a:latin typeface="Times New Roman" panose="02020603050405020304" pitchFamily="18" charset="0"/>
                <a:cs typeface="Times New Roman" panose="02020603050405020304" pitchFamily="18" charset="0"/>
              </a:rPr>
              <a:t>Figure S1:</a:t>
            </a:r>
            <a:r>
              <a:rPr lang="en-US" altLang="zh-CN" sz="1400" dirty="0">
                <a:latin typeface="Times New Roman" panose="02020603050405020304" pitchFamily="18" charset="0"/>
                <a:cs typeface="Times New Roman" panose="02020603050405020304" pitchFamily="18" charset="0"/>
              </a:rPr>
              <a:t>beta diversity binary </a:t>
            </a:r>
            <a:r>
              <a:rPr lang="en-US" altLang="zh-CN" sz="1400" dirty="0" err="1">
                <a:latin typeface="Times New Roman" panose="02020603050405020304" pitchFamily="18" charset="0"/>
                <a:cs typeface="Times New Roman" panose="02020603050405020304" pitchFamily="18" charset="0"/>
              </a:rPr>
              <a:t>jaccard</a:t>
            </a:r>
            <a:r>
              <a:rPr lang="en-US" altLang="zh-CN" sz="1400" dirty="0">
                <a:latin typeface="Times New Roman" panose="02020603050405020304" pitchFamily="18" charset="0"/>
                <a:cs typeface="Times New Roman" panose="02020603050405020304" pitchFamily="18" charset="0"/>
              </a:rPr>
              <a:t> . The left raw shows the sample clustering tree (same as UPGMA): Based on the four distance matrices obtained from the Beta diversity analysis, the samples are hierarchically clustered through the Python language tool to judge the similarity of the species composition among the samples; the right raw is the </a:t>
            </a:r>
            <a:r>
              <a:rPr lang="en-US" altLang="zh-CN" sz="1400" b="1" i="1" dirty="0">
                <a:latin typeface="Times New Roman" panose="02020603050405020304" pitchFamily="18" charset="0"/>
                <a:cs typeface="Times New Roman" panose="02020603050405020304" pitchFamily="18" charset="0"/>
              </a:rPr>
              <a:t>abundance</a:t>
            </a:r>
            <a:r>
              <a:rPr lang="en-US" altLang="zh-CN" sz="1400" dirty="0">
                <a:latin typeface="Times New Roman" panose="02020603050405020304" pitchFamily="18" charset="0"/>
                <a:cs typeface="Times New Roman" panose="02020603050405020304" pitchFamily="18" charset="0"/>
              </a:rPr>
              <a:t> histogram of each sample genus level is used to judge the similarity of species abundance among samples. The sample hierarchical clustering tree is as follows: sample clustering tree-the closer the sample, the shorter the branch length, indicating that the species composition of the two samples are more similar; abundance histogram-comparing the species of each sample according to the proportion of each color block. The level of diversity, similarity in abundance, and dominant species.</a:t>
            </a:r>
          </a:p>
          <a:p>
            <a:endParaRPr lang="en-US" altLang="zh-CN" sz="1400" dirty="0"/>
          </a:p>
          <a:p>
            <a:endParaRPr kumimoji="1" lang="en-US" altLang="zh-CN" sz="1400" dirty="0"/>
          </a:p>
        </p:txBody>
      </p:sp>
      <p:sp>
        <p:nvSpPr>
          <p:cNvPr id="80" name="Rectangle 79">
            <a:extLst>
              <a:ext uri="{FF2B5EF4-FFF2-40B4-BE49-F238E27FC236}">
                <a16:creationId xmlns:a16="http://schemas.microsoft.com/office/drawing/2014/main" id="{61707E60-CEC9-4661-AA82-69242EB4BD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6406116"/>
            <a:ext cx="12191998" cy="461774"/>
          </a:xfrm>
          <a:prstGeom prst="rect">
            <a:avLst/>
          </a:prstGeom>
          <a:gradFill>
            <a:gsLst>
              <a:gs pos="0">
                <a:srgbClr val="000000"/>
              </a:gs>
              <a:gs pos="100000">
                <a:schemeClr val="accent1">
                  <a:lumMod val="75000"/>
                </a:schemeClr>
              </a:gs>
            </a:gsLst>
            <a:lin ang="15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tangle 81">
            <a:extLst>
              <a:ext uri="{FF2B5EF4-FFF2-40B4-BE49-F238E27FC236}">
                <a16:creationId xmlns:a16="http://schemas.microsoft.com/office/drawing/2014/main" id="{8F035CD8-AE30-4146-96F2-036B0CE5E4F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8115300" y="6406115"/>
            <a:ext cx="4076698" cy="464399"/>
          </a:xfrm>
          <a:prstGeom prst="rect">
            <a:avLst/>
          </a:prstGeom>
          <a:gradFill>
            <a:gsLst>
              <a:gs pos="19000">
                <a:srgbClr val="000000">
                  <a:alpha val="46000"/>
                </a:srgbClr>
              </a:gs>
              <a:gs pos="99000">
                <a:schemeClr val="accent1"/>
              </a:gs>
            </a:gsLst>
            <a:lin ang="13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 name="内容占位符 6">
            <a:extLst>
              <a:ext uri="{FF2B5EF4-FFF2-40B4-BE49-F238E27FC236}">
                <a16:creationId xmlns:a16="http://schemas.microsoft.com/office/drawing/2014/main" id="{0E9BDC88-042F-4A52-9588-3327AAD40465}"/>
              </a:ext>
            </a:extLst>
          </p:cNvPr>
          <p:cNvPicPr>
            <a:picLocks noChangeAspect="1"/>
          </p:cNvPicPr>
          <p:nvPr/>
        </p:nvPicPr>
        <p:blipFill>
          <a:blip r:embed="rId3"/>
          <a:stretch>
            <a:fillRect/>
          </a:stretch>
        </p:blipFill>
        <p:spPr>
          <a:xfrm>
            <a:off x="8585596" y="315807"/>
            <a:ext cx="303969" cy="5713940"/>
          </a:xfrm>
          <a:prstGeom prst="rect">
            <a:avLst/>
          </a:prstGeom>
        </p:spPr>
      </p:pic>
    </p:spTree>
    <p:extLst>
      <p:ext uri="{BB962C8B-B14F-4D97-AF65-F5344CB8AC3E}">
        <p14:creationId xmlns:p14="http://schemas.microsoft.com/office/powerpoint/2010/main" val="106151290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883</TotalTime>
  <Words>145</Words>
  <Application>Microsoft Office PowerPoint</Application>
  <PresentationFormat>宽屏</PresentationFormat>
  <Paragraphs>2</Paragraphs>
  <Slides>1</Slides>
  <Notes>1</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等线</vt:lpstr>
      <vt:lpstr>等线 Light</vt:lpstr>
      <vt:lpstr>Arial</vt:lpstr>
      <vt:lpstr>Times New Roman</vt:lpstr>
      <vt:lpstr>Office 主题​​</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u Jintao</dc:creator>
  <cp:lastModifiedBy>Jintao Hu</cp:lastModifiedBy>
  <cp:revision>10</cp:revision>
  <dcterms:created xsi:type="dcterms:W3CDTF">2021-09-22T11:44:00Z</dcterms:created>
  <dcterms:modified xsi:type="dcterms:W3CDTF">2021-12-29T12:22:26Z</dcterms:modified>
</cp:coreProperties>
</file>